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618" y="-10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323FB-8818-4635-A009-653CEE39546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7EBD5-4456-4132-B2B6-AF1C8B2B771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6747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323FB-8818-4635-A009-653CEE39546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7EBD5-4456-4132-B2B6-AF1C8B2B771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370177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323FB-8818-4635-A009-653CEE39546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7EBD5-4456-4132-B2B6-AF1C8B2B771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411489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323FB-8818-4635-A009-653CEE39546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7EBD5-4456-4132-B2B6-AF1C8B2B771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854513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323FB-8818-4635-A009-653CEE39546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7EBD5-4456-4132-B2B6-AF1C8B2B771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3153862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323FB-8818-4635-A009-653CEE39546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7EBD5-4456-4132-B2B6-AF1C8B2B771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879165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323FB-8818-4635-A009-653CEE39546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7EBD5-4456-4132-B2B6-AF1C8B2B771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092395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323FB-8818-4635-A009-653CEE39546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7EBD5-4456-4132-B2B6-AF1C8B2B771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5039496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323FB-8818-4635-A009-653CEE39546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7EBD5-4456-4132-B2B6-AF1C8B2B771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538524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323FB-8818-4635-A009-653CEE39546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7EBD5-4456-4132-B2B6-AF1C8B2B771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23214320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AU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3323FB-8818-4635-A009-653CEE39546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AU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07EBD5-4456-4132-B2B6-AF1C8B2B771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1144556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AU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AU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3323FB-8818-4635-A009-653CEE395464}" type="datetimeFigureOut">
              <a:rPr lang="en-AU" smtClean="0"/>
              <a:t>11/02/2015</a:t>
            </a:fld>
            <a:endParaRPr lang="en-AU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AU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07EBD5-4456-4132-B2B6-AF1C8B2B7717}" type="slidenum">
              <a:rPr lang="en-AU" smtClean="0"/>
              <a:t>‹#›</a:t>
            </a:fld>
            <a:endParaRPr lang="en-AU"/>
          </a:p>
        </p:txBody>
      </p:sp>
    </p:spTree>
    <p:extLst>
      <p:ext uri="{BB962C8B-B14F-4D97-AF65-F5344CB8AC3E}">
        <p14:creationId xmlns:p14="http://schemas.microsoft.com/office/powerpoint/2010/main" val="42602443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 descr="E:\From old gel doc computer\HS_MspJI_Agro_50_4Enzy_test2.bmp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94" t="22614" r="37760" b="18758"/>
          <a:stretch/>
        </p:blipFill>
        <p:spPr bwMode="auto">
          <a:xfrm>
            <a:off x="2240240" y="2525527"/>
            <a:ext cx="4236504" cy="277568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1789778" y="2617167"/>
            <a:ext cx="4414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 smtClean="0">
                <a:latin typeface="Arial" pitchFamily="34" charset="0"/>
                <a:cs typeface="Arial" pitchFamily="34" charset="0"/>
              </a:rPr>
              <a:t>2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789778" y="2924944"/>
            <a:ext cx="44145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>
                <a:latin typeface="Arial" pitchFamily="34" charset="0"/>
                <a:cs typeface="Arial" pitchFamily="34" charset="0"/>
              </a:rPr>
              <a:t>1</a:t>
            </a:r>
            <a:r>
              <a:rPr lang="en-AU" sz="1400" dirty="0" smtClean="0">
                <a:latin typeface="Arial" pitchFamily="34" charset="0"/>
                <a:cs typeface="Arial" pitchFamily="34" charset="0"/>
              </a:rPr>
              <a:t>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645762" y="3284984"/>
            <a:ext cx="58547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 smtClean="0">
                <a:latin typeface="Arial" pitchFamily="34" charset="0"/>
                <a:cs typeface="Arial" pitchFamily="34" charset="0"/>
              </a:rPr>
              <a:t>0.5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403648" y="3789040"/>
            <a:ext cx="82758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 smtClean="0">
                <a:latin typeface="Arial" pitchFamily="34" charset="0"/>
                <a:cs typeface="Arial" pitchFamily="34" charset="0"/>
              </a:rPr>
              <a:t>0.25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655168" y="4365104"/>
            <a:ext cx="57606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AU" sz="1400" dirty="0" smtClean="0">
                <a:latin typeface="Arial" pitchFamily="34" charset="0"/>
                <a:cs typeface="Arial" pitchFamily="34" charset="0"/>
              </a:rPr>
              <a:t>0.1 k</a:t>
            </a:r>
            <a:endParaRPr lang="en-AU" sz="14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8000000">
            <a:off x="2281824" y="1704110"/>
            <a:ext cx="1392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molase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 rot="18000000">
            <a:off x="2727624" y="1700747"/>
            <a:ext cx="1392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ngoTaq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8000000">
            <a:off x="3159672" y="1700747"/>
            <a:ext cx="1392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fu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Straight Connector 15"/>
          <p:cNvCxnSpPr/>
          <p:nvPr/>
        </p:nvCxnSpPr>
        <p:spPr>
          <a:xfrm>
            <a:off x="2931726" y="1336635"/>
            <a:ext cx="164027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2873469" y="980728"/>
            <a:ext cx="1497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>
                <a:latin typeface="Arial" pitchFamily="34" charset="0"/>
                <a:cs typeface="Arial" pitchFamily="34" charset="0"/>
              </a:rPr>
              <a:t>3</a:t>
            </a:r>
            <a:r>
              <a:rPr lang="en-AU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AU" dirty="0">
                <a:latin typeface="Arial" pitchFamily="34" charset="0"/>
                <a:cs typeface="Arial" pitchFamily="34" charset="0"/>
              </a:rPr>
              <a:t>µM</a:t>
            </a:r>
          </a:p>
        </p:txBody>
      </p:sp>
      <p:sp>
        <p:nvSpPr>
          <p:cNvPr id="20" name="TextBox 19"/>
          <p:cNvSpPr txBox="1"/>
          <p:nvPr/>
        </p:nvSpPr>
        <p:spPr>
          <a:xfrm rot="18000000">
            <a:off x="3583743" y="1707378"/>
            <a:ext cx="1392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usion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8000000">
            <a:off x="4239792" y="1681678"/>
            <a:ext cx="1392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mmolase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8000000">
            <a:off x="4685592" y="1678315"/>
            <a:ext cx="1392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angoTaq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8000000">
            <a:off x="5117640" y="1678315"/>
            <a:ext cx="1392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fu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/>
          <p:cNvCxnSpPr/>
          <p:nvPr/>
        </p:nvCxnSpPr>
        <p:spPr>
          <a:xfrm>
            <a:off x="4889694" y="1314203"/>
            <a:ext cx="164027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4831437" y="958296"/>
            <a:ext cx="14971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smtClean="0">
                <a:latin typeface="Arial" pitchFamily="34" charset="0"/>
                <a:cs typeface="Arial" pitchFamily="34" charset="0"/>
              </a:rPr>
              <a:t>6 </a:t>
            </a:r>
            <a:r>
              <a:rPr lang="en-AU" dirty="0">
                <a:latin typeface="Arial" pitchFamily="34" charset="0"/>
                <a:cs typeface="Arial" pitchFamily="34" charset="0"/>
              </a:rPr>
              <a:t>µM</a:t>
            </a:r>
          </a:p>
        </p:txBody>
      </p:sp>
      <p:sp>
        <p:nvSpPr>
          <p:cNvPr id="26" name="TextBox 25"/>
          <p:cNvSpPr txBox="1"/>
          <p:nvPr/>
        </p:nvSpPr>
        <p:spPr>
          <a:xfrm rot="18000000">
            <a:off x="5541711" y="1684946"/>
            <a:ext cx="139247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husion</a:t>
            </a:r>
            <a:endParaRPr lang="en-AU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683568" y="476672"/>
            <a:ext cx="274029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AU" b="1" dirty="0">
                <a:latin typeface="Arial" panose="020B0604020202020204" pitchFamily="34" charset="0"/>
                <a:cs typeface="Arial" panose="020B0604020202020204" pitchFamily="34" charset="0"/>
              </a:rPr>
              <a:t>Additional </a:t>
            </a:r>
            <a:r>
              <a:rPr lang="en-AU" b="1" dirty="0" smtClean="0">
                <a:latin typeface="Arial" panose="020B0604020202020204" pitchFamily="34" charset="0"/>
                <a:cs typeface="Arial" panose="020B0604020202020204" pitchFamily="34" charset="0"/>
              </a:rPr>
              <a:t>file 2</a:t>
            </a:r>
            <a:endParaRPr lang="en-AU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434785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</TotalTime>
  <Words>25</Words>
  <Application>Microsoft Office PowerPoint</Application>
  <PresentationFormat>On-screen Show (4:3)</PresentationFormat>
  <Paragraphs>16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CenITex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iroshi Shinozuka</dc:creator>
  <cp:lastModifiedBy>Hiroshi Shinozuka</cp:lastModifiedBy>
  <cp:revision>6</cp:revision>
  <dcterms:created xsi:type="dcterms:W3CDTF">2014-03-06T01:08:40Z</dcterms:created>
  <dcterms:modified xsi:type="dcterms:W3CDTF">2015-02-11T04:17:17Z</dcterms:modified>
</cp:coreProperties>
</file>